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06" autoAdjust="0"/>
    <p:restoredTop sz="94660"/>
  </p:normalViewPr>
  <p:slideViewPr>
    <p:cSldViewPr>
      <p:cViewPr>
        <p:scale>
          <a:sx n="100" d="100"/>
          <a:sy n="100" d="100"/>
        </p:scale>
        <p:origin x="-8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765B0-3F02-498D-9749-19546128BCCC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2D905E-4C8C-4E18-9FB6-92220C1D2766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020DB-43A3-4BA1-8435-2D542A5E72D4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19E481-A26E-42D6-A7F1-4CF1D27C4CB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D88C38-CAB9-43E2-9A0F-86F8441D4809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677BA1-3E3C-4FB0-A1A4-DB966A2C116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61D3B7-850B-4F78-A6CE-68279399A90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9EA593-1A5D-42DB-8F22-0430B2A21A5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555135-35A0-4655-A1B4-81779B5EDD63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5BDD77-747E-4391-8B93-6437B1B095B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AF560-E28D-41A6-BAAE-F0FC375C19B2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EDD899-E24E-4977-85BE-1824FBE0890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3C162D-D1A2-4FAA-A190-CD43676B3ED3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645C74-3318-47A0-A685-5FFA5ABF82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3D1FEA-470A-42C7-A3F9-A73AC91E64F9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9EE1E9-0D3C-4A3D-A4BE-B009444092AE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BBCE86-1624-4CB8-9BB6-4157D2C73BC6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28F4EA-4360-408B-B657-BE49648BDD6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0518C9-953C-4890-9797-A73206F9A72A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8EE10C-DA7A-4B97-A48B-5A5E7999359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C3FE1-E4AF-44AA-8B21-45CBD76A93F2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1B6C6D-058F-4176-8988-99C7B0FEBF0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90F0E81-4EAD-493A-9BFB-7B179DCA8A55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C6E8E200-2259-4EB3-9B76-C731CAD714F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8"/>
          <p:cNvSpPr>
            <a:spLocks noChangeArrowheads="1"/>
          </p:cNvSpPr>
          <p:nvPr/>
        </p:nvSpPr>
        <p:spPr bwMode="auto">
          <a:xfrm>
            <a:off x="539552" y="332657"/>
            <a:ext cx="8208912" cy="504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eaLnBrk="0" fontAlgn="b" hangingPunct="0"/>
            <a:r>
              <a:rPr lang="en-GB" sz="1200" b="1" dirty="0">
                <a:cs typeface="Arial" charset="0"/>
              </a:rPr>
              <a:t> Table </a:t>
            </a:r>
            <a:r>
              <a:rPr lang="en-GB" sz="1200" b="1" dirty="0" smtClean="0">
                <a:cs typeface="Arial" charset="0"/>
              </a:rPr>
              <a:t>S1</a:t>
            </a:r>
            <a:r>
              <a:rPr lang="en-GB" sz="1200" b="1" dirty="0">
                <a:cs typeface="Arial" charset="0"/>
              </a:rPr>
              <a:t>.</a:t>
            </a:r>
            <a:r>
              <a:rPr lang="it-IT" sz="1200" b="1" dirty="0">
                <a:cs typeface="Arial" charset="0"/>
              </a:rPr>
              <a:t> </a:t>
            </a:r>
            <a:r>
              <a:rPr lang="it-IT" sz="1200" b="1" dirty="0" err="1">
                <a:cs typeface="Arial" charset="0"/>
              </a:rPr>
              <a:t>Fold</a:t>
            </a:r>
            <a:r>
              <a:rPr lang="it-IT" sz="1200" b="1" dirty="0">
                <a:cs typeface="Arial" charset="0"/>
              </a:rPr>
              <a:t> </a:t>
            </a:r>
            <a:r>
              <a:rPr lang="it-IT" sz="1200" b="1" dirty="0" err="1" smtClean="0">
                <a:cs typeface="Arial" charset="0"/>
              </a:rPr>
              <a:t>change</a:t>
            </a:r>
            <a:r>
              <a:rPr lang="it-IT" sz="1200" b="1" dirty="0" smtClean="0">
                <a:cs typeface="Arial" charset="0"/>
              </a:rPr>
              <a:t> </a:t>
            </a:r>
            <a:r>
              <a:rPr lang="it-IT" sz="1200" b="1" dirty="0" err="1" smtClean="0">
                <a:cs typeface="Arial" charset="0"/>
              </a:rPr>
              <a:t>values</a:t>
            </a:r>
            <a:r>
              <a:rPr lang="it-IT" sz="1200" b="1" dirty="0" smtClean="0">
                <a:cs typeface="Arial" charset="0"/>
              </a:rPr>
              <a:t> </a:t>
            </a:r>
            <a:r>
              <a:rPr lang="it-IT" sz="1200" b="1" dirty="0" err="1" smtClean="0">
                <a:cs typeface="Arial" charset="0"/>
              </a:rPr>
              <a:t>for</a:t>
            </a:r>
            <a:r>
              <a:rPr lang="it-IT" sz="1200" b="1" dirty="0" smtClean="0">
                <a:cs typeface="Arial" charset="0"/>
              </a:rPr>
              <a:t> 30 </a:t>
            </a:r>
            <a:r>
              <a:rPr lang="it-IT" sz="1200" b="1" dirty="0" err="1" smtClean="0">
                <a:cs typeface="Arial" charset="0"/>
              </a:rPr>
              <a:t>selected</a:t>
            </a:r>
            <a:r>
              <a:rPr lang="it-IT" sz="1200" b="1" dirty="0" smtClean="0">
                <a:cs typeface="Arial" charset="0"/>
              </a:rPr>
              <a:t> miRNAs in </a:t>
            </a:r>
            <a:r>
              <a:rPr lang="it-IT" sz="1200" b="1" dirty="0">
                <a:cs typeface="Arial" charset="0"/>
              </a:rPr>
              <a:t>IFN-</a:t>
            </a:r>
            <a:r>
              <a:rPr lang="it-IT" sz="1200" b="1" dirty="0">
                <a:cs typeface="Arial" charset="0"/>
                <a:sym typeface="Symbol" pitchFamily="18" charset="2"/>
              </a:rPr>
              <a:t></a:t>
            </a:r>
            <a:r>
              <a:rPr lang="it-IT" sz="1200" b="1" dirty="0">
                <a:cs typeface="Arial" charset="0"/>
              </a:rPr>
              <a:t> DC and IL-4 </a:t>
            </a:r>
            <a:r>
              <a:rPr lang="it-IT" sz="1200" b="1" dirty="0" smtClean="0">
                <a:cs typeface="Arial" charset="0"/>
              </a:rPr>
              <a:t>DC vs. </a:t>
            </a:r>
            <a:r>
              <a:rPr lang="it-IT" sz="1200" b="1" dirty="0" err="1" smtClean="0">
                <a:cs typeface="Arial" charset="0"/>
              </a:rPr>
              <a:t>GM-CSF-treated</a:t>
            </a:r>
            <a:r>
              <a:rPr lang="it-IT" sz="1200" b="1" dirty="0" smtClean="0">
                <a:cs typeface="Arial" charset="0"/>
              </a:rPr>
              <a:t> monocytes. </a:t>
            </a:r>
            <a:endParaRPr lang="en-GB" sz="1200" dirty="0">
              <a:cs typeface="Arial" charset="0"/>
            </a:endParaRPr>
          </a:p>
        </p:txBody>
      </p:sp>
      <p:graphicFrame>
        <p:nvGraphicFramePr>
          <p:cNvPr id="13973" name="Group 661"/>
          <p:cNvGraphicFramePr>
            <a:graphicFrameLocks noGrp="1"/>
          </p:cNvGraphicFramePr>
          <p:nvPr/>
        </p:nvGraphicFramePr>
        <p:xfrm>
          <a:off x="684213" y="1101725"/>
          <a:ext cx="7767637" cy="4624739"/>
        </p:xfrm>
        <a:graphic>
          <a:graphicData uri="http://schemas.openxmlformats.org/drawingml/2006/table">
            <a:tbl>
              <a:tblPr/>
              <a:tblGrid>
                <a:gridCol w="568325"/>
                <a:gridCol w="409575"/>
                <a:gridCol w="407987"/>
                <a:gridCol w="409575"/>
                <a:gridCol w="409575"/>
                <a:gridCol w="409575"/>
                <a:gridCol w="407988"/>
                <a:gridCol w="409575"/>
                <a:gridCol w="466725"/>
                <a:gridCol w="352425"/>
                <a:gridCol w="409575"/>
                <a:gridCol w="393700"/>
                <a:gridCol w="666750"/>
                <a:gridCol w="409575"/>
                <a:gridCol w="407987"/>
                <a:gridCol w="409575"/>
                <a:gridCol w="409575"/>
                <a:gridCol w="409575"/>
              </a:tblGrid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10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IFN</a:t>
                      </a:r>
                      <a:r>
                        <a:rPr kumimoji="0" lang="it-IT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sym typeface="Symbol"/>
                        </a:rPr>
                        <a:t> </a:t>
                      </a:r>
                      <a:r>
                        <a:rPr kumimoji="0" lang="it-IT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DC</a:t>
                      </a:r>
                      <a:r>
                        <a:rPr kumimoji="0" lang="it-IT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 </a:t>
                      </a:r>
                      <a:endParaRPr kumimoji="0" lang="it-IT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1" i="0" u="none" strike="noStrike" cap="none" normalizeH="0" baseline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400" b="1" i="0" u="none" strike="noStrike" cap="none" normalizeH="0" baseline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latin typeface="Arial" charset="0"/>
                        </a:rPr>
                        <a:t>IL4 DC</a:t>
                      </a:r>
                      <a:endParaRPr kumimoji="0" lang="it-IT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14763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2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4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5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6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7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8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9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10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b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2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4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Don.5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CFFFF"/>
                    </a:solidFill>
                  </a:tcPr>
                </a:tc>
              </a:tr>
              <a:tr h="1301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00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9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9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6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9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8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8.6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00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32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0.4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9.4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3.1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17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25b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5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3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8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6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25b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82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0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8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.6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01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3a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6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9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0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7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1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2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3a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46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</a:tr>
              <a:tr h="1301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30c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7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7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9.6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2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5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30c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3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17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e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5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6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6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e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4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7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7b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7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7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2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7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2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9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8.0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7b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6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2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32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9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32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3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7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1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6a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6a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05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0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7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.9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22.7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4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8.6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1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5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0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7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6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5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63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9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0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1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9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5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8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5</a:t>
                      </a:r>
                    </a:p>
                  </a:txBody>
                  <a:tcPr marL="7507" marR="7507" marT="7507" marB="0"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9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6</a:t>
                      </a:r>
                    </a:p>
                  </a:txBody>
                  <a:tcPr marL="7507" marR="7507" marT="7507" marB="0" anchor="ctr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3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.0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5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9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4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0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0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c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9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1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7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c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8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3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2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8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1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f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3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7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let-7f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5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9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8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8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1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8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5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9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9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1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9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4.9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9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9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49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6.3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4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7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0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5.5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7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8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5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0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7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7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4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7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50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3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7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7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6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2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6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9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8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2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8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8a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9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.8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8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4.9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0.6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9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9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8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8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2.8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2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3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01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28.2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9.9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2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8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7.7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8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4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4.1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1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5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8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7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9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1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43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5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3.2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12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86.9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5.0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7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9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212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82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9.1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7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2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6.3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9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9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2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6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9b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21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3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0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26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0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8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5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3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26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9.1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4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59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7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5.3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  <a:tr h="1397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81 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</a:t>
                      </a:r>
                      <a:r>
                        <a:rPr kumimoji="0" lang="it-IT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70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3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67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3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7507" marR="7507" marT="7507" marB="0" anchor="ctr" horzOverflow="overflow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miR-181 </a:t>
                      </a:r>
                    </a:p>
                  </a:txBody>
                  <a:tcPr marL="7507" marR="7507" marT="7507" marB="0" anchor="b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2.33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1.1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-1.04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2.86</a:t>
                      </a:r>
                    </a:p>
                  </a:txBody>
                  <a:tcPr marL="7507" marR="7507" marT="7507" marB="0" anchor="ctr" horzOverflow="overflow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2" name="Tabella 11"/>
          <p:cNvGraphicFramePr>
            <a:graphicFrameLocks noGrp="1"/>
          </p:cNvGraphicFramePr>
          <p:nvPr/>
        </p:nvGraphicFramePr>
        <p:xfrm>
          <a:off x="611188" y="5876925"/>
          <a:ext cx="5918200" cy="762000"/>
        </p:xfrm>
        <a:graphic>
          <a:graphicData uri="http://schemas.openxmlformats.org/drawingml/2006/table">
            <a:tbl>
              <a:tblPr/>
              <a:tblGrid>
                <a:gridCol w="5918200"/>
              </a:tblGrid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Each</a:t>
                      </a:r>
                      <a:r>
                        <a:rPr kumimoji="0" lang="it-IT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miRNA </a:t>
                      </a: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was</a:t>
                      </a:r>
                      <a:r>
                        <a:rPr kumimoji="0" lang="it-IT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</a:t>
                      </a: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considered</a:t>
                      </a:r>
                      <a:r>
                        <a:rPr kumimoji="0" lang="it-IT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: 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- Up-regulated if Fold-change </a:t>
                      </a:r>
                      <a:r>
                        <a:rPr kumimoji="0" lang="en-US" sz="11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vs</a:t>
                      </a: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</a:rPr>
                        <a:t>. GM-CSF cells was &gt; 1,2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8000"/>
                          </a:solidFill>
                          <a:effectLst/>
                          <a:latin typeface="Arial" charset="0"/>
                        </a:rPr>
                        <a:t>- Down-regulated if Fold-change </a:t>
                      </a:r>
                      <a:r>
                        <a:rPr kumimoji="0" lang="en-US" sz="11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8000"/>
                          </a:solidFill>
                          <a:effectLst/>
                          <a:latin typeface="Arial" charset="0"/>
                        </a:rPr>
                        <a:t>vs</a:t>
                      </a:r>
                      <a:r>
                        <a:rPr kumimoji="0" 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8000"/>
                          </a:solidFill>
                          <a:effectLst/>
                          <a:latin typeface="Arial" charset="0"/>
                        </a:rPr>
                        <a:t>. GM-CSF cells was &lt; -1,2</a:t>
                      </a: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.a.</a:t>
                      </a:r>
                      <a:r>
                        <a:rPr kumimoji="0" lang="it-IT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: </a:t>
                      </a: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not</a:t>
                      </a:r>
                      <a:r>
                        <a:rPr kumimoji="0" lang="it-IT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 </a:t>
                      </a:r>
                      <a:r>
                        <a:rPr kumimoji="0" lang="it-IT" sz="11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</a:rPr>
                        <a:t>available</a:t>
                      </a:r>
                      <a:endParaRPr kumimoji="0" lang="it-IT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</a:endParaRPr>
                    </a:p>
                  </a:txBody>
                  <a:tcPr marL="9525" marR="9525" marT="9525" marB="0" anchor="b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CasellaDiTesto 1847"/>
          <p:cNvSpPr txBox="1">
            <a:spLocks noChangeArrowheads="1"/>
          </p:cNvSpPr>
          <p:nvPr/>
        </p:nvSpPr>
        <p:spPr bwMode="auto">
          <a:xfrm>
            <a:off x="2771800" y="4077072"/>
            <a:ext cx="48418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457200"/>
            <a:r>
              <a:rPr lang="it-IT" sz="1000" dirty="0">
                <a:cs typeface="Arial" pitchFamily="34" charset="0"/>
              </a:rPr>
              <a:t>***</a:t>
            </a:r>
          </a:p>
        </p:txBody>
      </p:sp>
      <p:sp>
        <p:nvSpPr>
          <p:cNvPr id="6" name="CasellaDiTesto 1847"/>
          <p:cNvSpPr txBox="1">
            <a:spLocks noChangeArrowheads="1"/>
          </p:cNvSpPr>
          <p:nvPr/>
        </p:nvSpPr>
        <p:spPr bwMode="auto">
          <a:xfrm>
            <a:off x="2924200" y="4229472"/>
            <a:ext cx="48418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defTabSz="457200"/>
            <a:r>
              <a:rPr lang="it-IT" sz="1000" dirty="0">
                <a:cs typeface="Arial" pitchFamily="34" charset="0"/>
              </a:rPr>
              <a:t>**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6</TotalTime>
  <Words>656</Words>
  <Application>Microsoft Office PowerPoint</Application>
  <PresentationFormat>Presentazione su schermo (4:3)</PresentationFormat>
  <Paragraphs>4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abriele_lucia</dc:creator>
  <cp:lastModifiedBy>gabriele_lucia</cp:lastModifiedBy>
  <cp:revision>14</cp:revision>
  <dcterms:created xsi:type="dcterms:W3CDTF">2013-05-30T11:30:53Z</dcterms:created>
  <dcterms:modified xsi:type="dcterms:W3CDTF">2013-08-05T13:14:21Z</dcterms:modified>
</cp:coreProperties>
</file>